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390" y="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ktangel 2"/>
          <p:cNvSpPr/>
          <p:nvPr/>
        </p:nvSpPr>
        <p:spPr>
          <a:xfrm>
            <a:off x="228600" y="3022937"/>
            <a:ext cx="648482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1200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2 Fig</a:t>
            </a:r>
            <a:r>
              <a:rPr lang="en-US" sz="120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V does not cause increased cell death late after infection.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evel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DH in supernatants were determined by an LDH activity assay, and then data from ANDV-infected models were compared to that of uninfected models at the specific time-point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 mean ± SEM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e experiment with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wo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fected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two uninfected models. FFU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focus forming units. dpi; days post infection.</a:t>
            </a:r>
            <a:endParaRPr lang="sv-S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Bildobjekt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90500"/>
            <a:ext cx="3933825" cy="2857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01</TotalTime>
  <Words>73</Words>
  <Application>Microsoft Office PowerPoint</Application>
  <PresentationFormat>Bildspel på skärme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-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ild 1</dc:title>
  <dc:creator>Shawon Gupta</dc:creator>
  <cp:lastModifiedBy>Jonas Klingström</cp:lastModifiedBy>
  <cp:revision>118</cp:revision>
  <cp:lastPrinted>2015-09-07T14:02:09Z</cp:lastPrinted>
  <dcterms:created xsi:type="dcterms:W3CDTF">2012-05-16T12:12:27Z</dcterms:created>
  <dcterms:modified xsi:type="dcterms:W3CDTF">2016-02-12T12:15:27Z</dcterms:modified>
</cp:coreProperties>
</file>